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C54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0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50C003-09E4-274F-A5B4-F1C5EABF74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476DBBF-F355-F64E-963D-A995689C53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6368FB-7B10-5342-81F3-D1EE477D0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3AA213-E15E-8548-8EFB-72EE9B40C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5CCDEA-FF5F-9645-AAB4-58DC68958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058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F9C39E-EE11-7841-81B2-0E4C426D2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915B00F-E917-234E-8096-88AA771E69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C5F4FD-545E-9E49-9442-5071A2982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B1F902-5631-A043-8FC2-DF26DA8A1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060833-1801-244C-9CE5-095CB0B75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224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E9F301D-8C98-7E48-A5BE-F812738CF1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F667DB4-6936-7F4B-A49F-D4ED7829D1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5AE205-8361-B249-A62A-64DD9BEE9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BDB57D-2801-7C41-AC3E-5DFBB8CC0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13B5B8-47D4-3747-8BF1-2C90719E5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561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2401D4-3AFC-4F48-8D9B-F8EBFB6A05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D9C7850-84BC-CF47-9833-E29EF8E3BB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54C7F4-57A9-C846-9635-61D0B9DF1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AF20DA-3430-264F-B043-288F1B88F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659859-BEC8-5E4C-9C17-61CCDBDCE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5972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59EA6B-2F59-E541-B712-4E34C369B7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01B5DDF-78D6-4B4A-8716-4515CDC501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7762B8-4569-E74A-BC6D-33AEA0065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202AA8-2CE3-4746-92C9-08C2D861E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258213-F65F-014D-AC68-E024B37EA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4676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E23CB1-BA0D-E642-B050-E98149C3B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9800C65-3DC7-C84B-9915-BB3C70BAF5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F59478D-B52C-B84A-9B1C-897F5482D7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A9C6D4-A745-EE4D-90F0-5269E18AF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380F80-E02C-6C40-91C6-D2D39FE59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D9BDBA0-2C14-F34D-85FD-5E13872A6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1830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EE1A64-3985-3749-A8CE-8AB95BAD1C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15FE43-EB2B-4145-B8DA-BA177749DD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B2EA192-B3AF-A643-AC73-5F2FA5C721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C9B7510-23A3-104E-8D41-7756D5A423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A267E06-13A8-374D-8C4C-C89B4A253C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AE02515-9BE6-1E4B-8891-2530B961A6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4513AE4-2C83-B045-8716-42EBFD11B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6116D6A-BE3B-DB4B-ABE6-958DFDB52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9194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38D47C-7F10-724D-8FAB-B1C8D6E546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AE8298E-BBEE-2347-952E-9C1B24252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B083045-108B-F646-A8C9-B152872CF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F8F9960-A60D-BF41-82A8-B3F422EAF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136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6CF68AC-DE26-EE41-8B93-F4DBA0420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43458DC-BB23-8545-86F3-8FE173FE7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1D26174-1A26-B546-9368-69426DB63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562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24BCB6-6A9C-C647-BAC0-2D9AADF2B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F2A797E-7372-814E-B05F-45B4EE39D4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1D1053-7EE4-D248-B2F2-FDD4B0FB5B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D011136-59D5-0D45-A106-C348E8AD0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46588A-D898-9A48-A99F-F7FA9CB46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C5654A-A8F8-F745-A3FC-BC534E343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085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A9A428-E579-2345-BD59-FF24A33DF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6B5AB0-E505-E443-8091-2025D45054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FD64F5-60FA-6A4F-B76E-09A0BEB87E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21CF69B-50FA-A645-A9F2-8463D8E27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46966F-BABE-AA4F-9CAD-732A911E1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FE99E9-B226-4148-8E1E-4BF4781E6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168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36D3C88-FE2A-C249-8689-E373705CD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5F91E1-2A33-7648-8608-072DA3BF6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07AA849-7651-EE4E-BEFF-6F56C0CB77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673572-C8BC-3B41-8B80-7A0A57AD48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D7EC26-0C0C-DF4A-8418-0C0C0362A7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123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0C4C18E-3B71-7054-A0A8-01E06A6F4E73}"/>
              </a:ext>
            </a:extLst>
          </p:cNvPr>
          <p:cNvSpPr txBox="1"/>
          <p:nvPr/>
        </p:nvSpPr>
        <p:spPr>
          <a:xfrm>
            <a:off x="3735223" y="454856"/>
            <a:ext cx="856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KMS26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E1DBD44-072B-867E-2958-17A3900C27D5}"/>
              </a:ext>
            </a:extLst>
          </p:cNvPr>
          <p:cNvSpPr txBox="1"/>
          <p:nvPr/>
        </p:nvSpPr>
        <p:spPr>
          <a:xfrm>
            <a:off x="5755338" y="454856"/>
            <a:ext cx="856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KMS27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EAA96FA-DE6F-9FB6-5CEF-FC8F42CAEF5F}"/>
              </a:ext>
            </a:extLst>
          </p:cNvPr>
          <p:cNvSpPr txBox="1"/>
          <p:nvPr/>
        </p:nvSpPr>
        <p:spPr>
          <a:xfrm>
            <a:off x="7741152" y="454856"/>
            <a:ext cx="856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KMS28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943B722-0461-62CF-7773-52A5FB315EDD}"/>
              </a:ext>
            </a:extLst>
          </p:cNvPr>
          <p:cNvSpPr txBox="1"/>
          <p:nvPr/>
        </p:nvSpPr>
        <p:spPr>
          <a:xfrm>
            <a:off x="9673966" y="459520"/>
            <a:ext cx="11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RPMI8226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677E133-3E17-8C8D-F08F-88D46B049219}"/>
              </a:ext>
            </a:extLst>
          </p:cNvPr>
          <p:cNvSpPr txBox="1"/>
          <p:nvPr/>
        </p:nvSpPr>
        <p:spPr>
          <a:xfrm>
            <a:off x="71270" y="1262805"/>
            <a:ext cx="128811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Bortezomib</a:t>
            </a:r>
          </a:p>
          <a:p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    4nM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0975010-D096-F5B6-2442-7424B61810A0}"/>
              </a:ext>
            </a:extLst>
          </p:cNvPr>
          <p:cNvSpPr txBox="1"/>
          <p:nvPr/>
        </p:nvSpPr>
        <p:spPr>
          <a:xfrm>
            <a:off x="148214" y="3848349"/>
            <a:ext cx="12121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Melphalan</a:t>
            </a:r>
          </a:p>
          <a:p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   50μM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id="{8661D735-ED26-D763-8496-744C7E66EE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2198" y="844505"/>
            <a:ext cx="1663700" cy="1663700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AE90FF90-5ED7-8EAD-3F45-BE54575D9A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92198" y="3114677"/>
            <a:ext cx="1663700" cy="1663700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D24E3B9F-3A51-8A5D-9ED3-803820AA4A7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66696" y="824750"/>
            <a:ext cx="1663700" cy="1663700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E30AA455-A781-91D1-BA8C-F6D5934A328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04160" y="3060735"/>
            <a:ext cx="1663700" cy="1663700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FC356523-8A0E-5DED-DADB-D976BF8E28D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29447" y="824750"/>
            <a:ext cx="1663700" cy="1663700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31CD4848-D199-1CD9-4349-08FED73FA46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26422" y="3066765"/>
            <a:ext cx="1663700" cy="1663700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D393429B-BAB2-90C7-133F-2F6E60EAB0D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503945" y="844505"/>
            <a:ext cx="1663700" cy="1663700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0ECFE446-A851-8D5E-3D86-6FCE6EADA0F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503945" y="3060735"/>
            <a:ext cx="1663700" cy="1663700"/>
          </a:xfrm>
          <a:prstGeom prst="rect">
            <a:avLst/>
          </a:prstGeom>
        </p:spPr>
      </p:pic>
      <p:cxnSp>
        <p:nvCxnSpPr>
          <p:cNvPr id="42" name="直線矢印コネクタ 41">
            <a:extLst>
              <a:ext uri="{FF2B5EF4-FFF2-40B4-BE49-F238E27FC236}">
                <a16:creationId xmlns:a16="http://schemas.microsoft.com/office/drawing/2014/main" id="{69C9F4EF-22A6-425C-20A3-9360C8911D46}"/>
              </a:ext>
            </a:extLst>
          </p:cNvPr>
          <p:cNvCxnSpPr>
            <a:cxnSpLocks/>
          </p:cNvCxnSpPr>
          <p:nvPr/>
        </p:nvCxnSpPr>
        <p:spPr>
          <a:xfrm>
            <a:off x="1385316" y="5064709"/>
            <a:ext cx="978232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A145E15-A0EF-27FF-7D69-7F3216021CEE}"/>
              </a:ext>
            </a:extLst>
          </p:cNvPr>
          <p:cNvSpPr txBox="1"/>
          <p:nvPr/>
        </p:nvSpPr>
        <p:spPr>
          <a:xfrm>
            <a:off x="10482842" y="5166376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CD26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44" name="図 43">
            <a:extLst>
              <a:ext uri="{FF2B5EF4-FFF2-40B4-BE49-F238E27FC236}">
                <a16:creationId xmlns:a16="http://schemas.microsoft.com/office/drawing/2014/main" id="{829F5DA1-74E0-285B-7D3F-1BF98E9D64F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82952" y="844505"/>
            <a:ext cx="1663700" cy="1663700"/>
          </a:xfrm>
          <a:prstGeom prst="rect">
            <a:avLst/>
          </a:prstGeom>
        </p:spPr>
      </p:pic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D397DEFC-C49C-D88C-C655-3E0B3ABCD3E8}"/>
              </a:ext>
            </a:extLst>
          </p:cNvPr>
          <p:cNvSpPr txBox="1"/>
          <p:nvPr/>
        </p:nvSpPr>
        <p:spPr>
          <a:xfrm>
            <a:off x="1769532" y="465534"/>
            <a:ext cx="856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KMS11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142206BE-F5CE-50B4-E70D-EAD0A0D1763B}"/>
              </a:ext>
            </a:extLst>
          </p:cNvPr>
          <p:cNvCxnSpPr>
            <a:cxnSpLocks/>
          </p:cNvCxnSpPr>
          <p:nvPr/>
        </p:nvCxnSpPr>
        <p:spPr>
          <a:xfrm>
            <a:off x="11450248" y="3935839"/>
            <a:ext cx="282388" cy="0"/>
          </a:xfrm>
          <a:prstGeom prst="line">
            <a:avLst/>
          </a:prstGeom>
          <a:ln w="1270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A8AB39D0-F846-BAAD-A142-376F4E352DCB}"/>
              </a:ext>
            </a:extLst>
          </p:cNvPr>
          <p:cNvCxnSpPr>
            <a:cxnSpLocks/>
          </p:cNvCxnSpPr>
          <p:nvPr/>
        </p:nvCxnSpPr>
        <p:spPr>
          <a:xfrm>
            <a:off x="11450248" y="4081764"/>
            <a:ext cx="282388" cy="0"/>
          </a:xfrm>
          <a:prstGeom prst="line">
            <a:avLst/>
          </a:prstGeom>
          <a:ln w="127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09809845-09EC-17AB-AD0B-3C4139FDD7B8}"/>
              </a:ext>
            </a:extLst>
          </p:cNvPr>
          <p:cNvCxnSpPr/>
          <p:nvPr/>
        </p:nvCxnSpPr>
        <p:spPr>
          <a:xfrm>
            <a:off x="11450248" y="4217462"/>
            <a:ext cx="282388" cy="0"/>
          </a:xfrm>
          <a:prstGeom prst="line">
            <a:avLst/>
          </a:prstGeom>
          <a:ln w="127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BDB5C727-535D-260F-806D-6C15DAB97E94}"/>
              </a:ext>
            </a:extLst>
          </p:cNvPr>
          <p:cNvCxnSpPr/>
          <p:nvPr/>
        </p:nvCxnSpPr>
        <p:spPr>
          <a:xfrm>
            <a:off x="11450248" y="4370092"/>
            <a:ext cx="282388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F1E8A9F0-919A-3EB9-1334-5DD6C0E0F24C}"/>
              </a:ext>
            </a:extLst>
          </p:cNvPr>
          <p:cNvCxnSpPr/>
          <p:nvPr/>
        </p:nvCxnSpPr>
        <p:spPr>
          <a:xfrm>
            <a:off x="11450248" y="4529808"/>
            <a:ext cx="282388" cy="0"/>
          </a:xfrm>
          <a:prstGeom prst="line">
            <a:avLst/>
          </a:prstGeom>
          <a:ln w="127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673A9C02-B11E-B217-C4FF-E42904D6D596}"/>
              </a:ext>
            </a:extLst>
          </p:cNvPr>
          <p:cNvSpPr txBox="1"/>
          <p:nvPr/>
        </p:nvSpPr>
        <p:spPr>
          <a:xfrm>
            <a:off x="11699867" y="3801089"/>
            <a:ext cx="49213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Iso</a:t>
            </a:r>
          </a:p>
          <a:p>
            <a:r>
              <a:rPr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0hr</a:t>
            </a:r>
          </a:p>
          <a:p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24hr</a:t>
            </a:r>
          </a:p>
          <a:p>
            <a:r>
              <a:rPr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48hr</a:t>
            </a:r>
          </a:p>
          <a:p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72hr</a:t>
            </a:r>
            <a:endParaRPr kumimoji="1" lang="ja-JP" altLang="en-US" sz="10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864BFF78-3A01-E009-BDA7-59BD6D118C77}"/>
              </a:ext>
            </a:extLst>
          </p:cNvPr>
          <p:cNvSpPr/>
          <p:nvPr/>
        </p:nvSpPr>
        <p:spPr>
          <a:xfrm>
            <a:off x="11368085" y="3801089"/>
            <a:ext cx="729101" cy="861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pic>
        <p:nvPicPr>
          <p:cNvPr id="53" name="図 52">
            <a:extLst>
              <a:ext uri="{FF2B5EF4-FFF2-40B4-BE49-F238E27FC236}">
                <a16:creationId xmlns:a16="http://schemas.microsoft.com/office/drawing/2014/main" id="{2BCDC860-39B3-4D6C-D786-B0D65B6E057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344852" y="3038477"/>
            <a:ext cx="1739900" cy="17399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607D238-466A-2675-D8F9-63DD127CC080}"/>
              </a:ext>
            </a:extLst>
          </p:cNvPr>
          <p:cNvSpPr txBox="1"/>
          <p:nvPr/>
        </p:nvSpPr>
        <p:spPr>
          <a:xfrm>
            <a:off x="238004" y="91383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</a:t>
            </a:r>
            <a:r>
              <a:rPr kumimoji="1" lang="en-US" altLang="ja-JP" b="1">
                <a:latin typeface="Calibri" panose="020F0502020204030204" pitchFamily="34" charset="0"/>
                <a:cs typeface="Calibri" panose="020F0502020204030204" pitchFamily="34" charset="0"/>
              </a:rPr>
              <a:t>Figure S1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95960AE-874A-35E8-1DDB-C7E7D66867AB}"/>
              </a:ext>
            </a:extLst>
          </p:cNvPr>
          <p:cNvSpPr txBox="1"/>
          <p:nvPr/>
        </p:nvSpPr>
        <p:spPr>
          <a:xfrm>
            <a:off x="681445" y="5374881"/>
            <a:ext cx="10620688" cy="13245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igure S1.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Effects of bortezomib or melphalan on CD26 expression on myeloma cells. Overlay histograms show CD26 expression on KMS11, 26, 27, 28 and RPMI8226 before or after treatment with bortezomib at 4 </a:t>
            </a:r>
            <a:r>
              <a:rPr lang="en-U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nM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or melphalan at 50 </a:t>
            </a:r>
            <a:r>
              <a:rPr lang="en-US" altLang="ja-JP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μM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 for the indicated times (24, 48 and 72 hours). Neither agents altered the expression levels of CD26 in each myeloma cell line.</a:t>
            </a:r>
            <a:endParaRPr lang="ja-JP" altLang="ja-JP" sz="140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5351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2</TotalTime>
  <Words>91</Words>
  <Application>Microsoft Macintosh PowerPoint</Application>
  <PresentationFormat>ワイド画面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ishidaHiroko</dc:creator>
  <cp:lastModifiedBy> </cp:lastModifiedBy>
  <cp:revision>182</cp:revision>
  <cp:lastPrinted>2022-10-01T05:59:48Z</cp:lastPrinted>
  <dcterms:created xsi:type="dcterms:W3CDTF">2022-04-14T05:37:04Z</dcterms:created>
  <dcterms:modified xsi:type="dcterms:W3CDTF">2024-01-18T09:06:35Z</dcterms:modified>
</cp:coreProperties>
</file>